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3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16/11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fr-F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l="4392" t="16601" r="26976" b="5274"/>
          <a:stretch>
            <a:fillRect/>
          </a:stretch>
        </p:blipFill>
        <p:spPr bwMode="auto">
          <a:xfrm>
            <a:off x="-32" y="928670"/>
            <a:ext cx="9197706" cy="588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/>
          <p:cNvSpPr txBox="1"/>
          <p:nvPr/>
        </p:nvSpPr>
        <p:spPr>
          <a:xfrm>
            <a:off x="-32" y="500042"/>
            <a:ext cx="3643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(a) M5 motif</a:t>
            </a:r>
            <a:endParaRPr lang="fr-FR" dirty="0"/>
          </a:p>
        </p:txBody>
      </p:sp>
      <p:sp>
        <p:nvSpPr>
          <p:cNvPr id="7" name="Text Box 1"/>
          <p:cNvSpPr txBox="1">
            <a:spLocks noChangeArrowheads="1"/>
          </p:cNvSpPr>
          <p:nvPr/>
        </p:nvSpPr>
        <p:spPr bwMode="auto">
          <a:xfrm>
            <a:off x="14318" y="-15190"/>
            <a:ext cx="9272590" cy="5715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anchor="ctr"/>
          <a:lstStyle/>
          <a:p>
            <a:pPr algn="ctr" eaLnBrk="0" hangingPunct="0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fr-FR" sz="1600" b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dditional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le 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2 (Tables S1)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32" y="559338"/>
            <a:ext cx="3643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(b) M7 motif</a:t>
            </a:r>
            <a:endParaRPr lang="fr-FR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14068" y="952519"/>
            <a:ext cx="9163050" cy="519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 Box 1"/>
          <p:cNvSpPr txBox="1">
            <a:spLocks noChangeArrowheads="1"/>
          </p:cNvSpPr>
          <p:nvPr/>
        </p:nvSpPr>
        <p:spPr bwMode="auto">
          <a:xfrm>
            <a:off x="14318" y="-15190"/>
            <a:ext cx="9272590" cy="5715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anchor="ctr"/>
          <a:lstStyle/>
          <a:p>
            <a:pPr algn="ctr" eaLnBrk="0" hangingPunct="0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fr-FR" sz="1600" b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dditional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le 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2 (Tables S1)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385294" y="487900"/>
            <a:ext cx="3643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(c) M4 motif</a:t>
            </a:r>
            <a:endParaRPr lang="fr-FR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 l="3843" t="8789" r="30820" b="7365"/>
          <a:stretch>
            <a:fillRect/>
          </a:stretch>
        </p:blipFill>
        <p:spPr bwMode="auto">
          <a:xfrm>
            <a:off x="428596" y="928670"/>
            <a:ext cx="8119049" cy="5857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 Box 1"/>
          <p:cNvSpPr txBox="1">
            <a:spLocks noChangeArrowheads="1"/>
          </p:cNvSpPr>
          <p:nvPr/>
        </p:nvSpPr>
        <p:spPr bwMode="auto">
          <a:xfrm>
            <a:off x="14318" y="-15190"/>
            <a:ext cx="9272590" cy="5715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anchor="ctr"/>
          <a:lstStyle/>
          <a:p>
            <a:pPr algn="ctr" eaLnBrk="0" hangingPunct="0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fr-FR" sz="1600" b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dditional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le 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2 (Tables S1)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32" y="916528"/>
            <a:ext cx="3643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(d) M8 motif</a:t>
            </a:r>
            <a:endParaRPr lang="fr-FR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0639" y="1305704"/>
            <a:ext cx="8951119" cy="46405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 Box 1"/>
          <p:cNvSpPr txBox="1">
            <a:spLocks noChangeArrowheads="1"/>
          </p:cNvSpPr>
          <p:nvPr/>
        </p:nvSpPr>
        <p:spPr bwMode="auto">
          <a:xfrm>
            <a:off x="14318" y="71418"/>
            <a:ext cx="9272590" cy="5715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anchor="ctr"/>
          <a:lstStyle/>
          <a:p>
            <a:pPr algn="ctr" eaLnBrk="0" hangingPunct="0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fr-FR" sz="1600" b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dditional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le 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2 (Tables S1)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71470" y="1059404"/>
            <a:ext cx="3643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(e) M6 motif</a:t>
            </a:r>
            <a:endParaRPr lang="fr-FR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l="5156" t="12695" r="25878" b="22851"/>
          <a:stretch>
            <a:fillRect/>
          </a:stretch>
        </p:blipFill>
        <p:spPr bwMode="auto">
          <a:xfrm>
            <a:off x="15134" y="1428736"/>
            <a:ext cx="9152735" cy="4809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 Box 1"/>
          <p:cNvSpPr txBox="1">
            <a:spLocks noChangeArrowheads="1"/>
          </p:cNvSpPr>
          <p:nvPr/>
        </p:nvSpPr>
        <p:spPr bwMode="auto">
          <a:xfrm>
            <a:off x="14318" y="142856"/>
            <a:ext cx="9272590" cy="5715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anchor="ctr"/>
          <a:lstStyle/>
          <a:p>
            <a:pPr algn="ctr" eaLnBrk="0" hangingPunct="0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fr-FR" sz="1600" b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dditional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le </a:t>
            </a:r>
            <a:r>
              <a:rPr lang="fr-FR" sz="16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2 (Tables S1)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PresentationFormat>Affichage à l'écran (4:3)</PresentationFormat>
  <Paragraphs>10</Paragraphs>
  <Slides>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Diapositive 1</vt:lpstr>
      <vt:lpstr>Diapositive 2</vt:lpstr>
      <vt:lpstr>Diapositive 3</vt:lpstr>
      <vt:lpstr>Diapositive 4</vt:lpstr>
      <vt:lpstr>Diapositiv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User</dc:creator>
  <cp:lastModifiedBy>User</cp:lastModifiedBy>
  <cp:revision>1</cp:revision>
  <dcterms:created xsi:type="dcterms:W3CDTF">2017-11-16T11:36:44Z</dcterms:created>
  <dcterms:modified xsi:type="dcterms:W3CDTF">2017-11-16T11:37:13Z</dcterms:modified>
</cp:coreProperties>
</file>